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7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221" autoAdjust="0"/>
    <p:restoredTop sz="94660"/>
  </p:normalViewPr>
  <p:slideViewPr>
    <p:cSldViewPr showGuides="1">
      <p:cViewPr varScale="1">
        <p:scale>
          <a:sx n="70" d="100"/>
          <a:sy n="70" d="100"/>
        </p:scale>
        <p:origin x="1196" y="5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E:\NRC%20pomegranate\NRCP%202021\lab%20papers\in%20progress\endophytes_RA\endophyte%20establishment\Endophyte-Xap%20recovery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overlay val="0"/>
      <c:spPr>
        <a:noFill/>
        <a:ln>
          <a:noFill/>
        </a:ln>
        <a:effectLst/>
      </c:spPr>
      <c:txPr>
        <a:bodyPr rot="0" vert="horz"/>
        <a:lstStyle/>
        <a:p>
          <a:pPr>
            <a:defRPr/>
          </a:pPr>
          <a:endParaRPr lang="en-US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'Sheet3 (RA)'!$G$2</c:f>
              <c:strCache>
                <c:ptCount val="1"/>
                <c:pt idx="0">
                  <c:v>TC310</c:v>
                </c:pt>
              </c:strCache>
            </c:strRef>
          </c:tx>
          <c:spPr>
            <a:ln w="28575" cap="rnd">
              <a:solidFill>
                <a:schemeClr val="dk1">
                  <a:tint val="88500"/>
                </a:schemeClr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'Sheet3 (RA)'!$H$5:$N$5</c:f>
                <c:numCache>
                  <c:formatCode>General</c:formatCode>
                  <c:ptCount val="7"/>
                  <c:pt idx="0">
                    <c:v>0.5670115145331418</c:v>
                  </c:pt>
                  <c:pt idx="1">
                    <c:v>1.7010345435994254</c:v>
                  </c:pt>
                  <c:pt idx="2">
                    <c:v>4.0824829046386304</c:v>
                  </c:pt>
                  <c:pt idx="3">
                    <c:v>2.4124145231931999</c:v>
                  </c:pt>
                  <c:pt idx="4">
                    <c:v>1.9913001278732001</c:v>
                  </c:pt>
                  <c:pt idx="5">
                    <c:v>1.6082763487953999</c:v>
                  </c:pt>
                  <c:pt idx="6">
                    <c:v>0</c:v>
                  </c:pt>
                </c:numCache>
              </c:numRef>
            </c:plus>
            <c:minus>
              <c:numRef>
                <c:f>'Sheet3 (RA)'!$H$5:$N$5</c:f>
                <c:numCache>
                  <c:formatCode>General</c:formatCode>
                  <c:ptCount val="7"/>
                  <c:pt idx="0">
                    <c:v>0.5670115145331418</c:v>
                  </c:pt>
                  <c:pt idx="1">
                    <c:v>1.7010345435994254</c:v>
                  </c:pt>
                  <c:pt idx="2">
                    <c:v>4.0824829046386304</c:v>
                  </c:pt>
                  <c:pt idx="3">
                    <c:v>2.4124145231931999</c:v>
                  </c:pt>
                  <c:pt idx="4">
                    <c:v>1.9913001278732001</c:v>
                  </c:pt>
                  <c:pt idx="5">
                    <c:v>1.6082763487953999</c:v>
                  </c:pt>
                  <c:pt idx="6">
                    <c:v>0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Sheet3 (RA)'!$H$1:$N$1</c:f>
              <c:strCache>
                <c:ptCount val="7"/>
                <c:pt idx="0">
                  <c:v>1d</c:v>
                </c:pt>
                <c:pt idx="1">
                  <c:v>2d</c:v>
                </c:pt>
                <c:pt idx="2">
                  <c:v>3d</c:v>
                </c:pt>
                <c:pt idx="3">
                  <c:v>4d</c:v>
                </c:pt>
                <c:pt idx="4">
                  <c:v>5d</c:v>
                </c:pt>
                <c:pt idx="5">
                  <c:v>6d</c:v>
                </c:pt>
                <c:pt idx="6">
                  <c:v>7d</c:v>
                </c:pt>
              </c:strCache>
            </c:strRef>
          </c:cat>
          <c:val>
            <c:numRef>
              <c:f>'Sheet3 (RA)'!$H$2:$N$2</c:f>
              <c:numCache>
                <c:formatCode>0</c:formatCode>
                <c:ptCount val="7"/>
                <c:pt idx="0">
                  <c:v>88.194444444444443</c:v>
                </c:pt>
                <c:pt idx="1">
                  <c:v>85.416666666666671</c:v>
                </c:pt>
                <c:pt idx="2" formatCode="General">
                  <c:v>95</c:v>
                </c:pt>
                <c:pt idx="3">
                  <c:v>75</c:v>
                </c:pt>
                <c:pt idx="4">
                  <c:v>63.461538461538467</c:v>
                </c:pt>
                <c:pt idx="5">
                  <c:v>83.333333333333329</c:v>
                </c:pt>
                <c:pt idx="6">
                  <c:v>28.57142857142856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44F9-4A6A-A4F8-B9141ADD039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152956288"/>
        <c:axId val="152958080"/>
      </c:lineChart>
      <c:catAx>
        <c:axId val="152956288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IN" dirty="0"/>
                  <a:t>Days post inoculation</a:t>
                </a:r>
              </a:p>
            </c:rich>
          </c:tx>
          <c:layout>
            <c:manualLayout>
              <c:xMode val="edge"/>
              <c:yMode val="edge"/>
              <c:x val="0.38922460759195454"/>
              <c:y val="0.89782407407407405"/>
            </c:manualLayout>
          </c:layout>
          <c:overlay val="0"/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152958080"/>
        <c:crosses val="autoZero"/>
        <c:auto val="1"/>
        <c:lblAlgn val="ctr"/>
        <c:lblOffset val="100"/>
        <c:noMultiLvlLbl val="0"/>
      </c:catAx>
      <c:valAx>
        <c:axId val="15295808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/>
              <a:lstStyle/>
              <a:p>
                <a:pPr>
                  <a:defRPr/>
                </a:pPr>
                <a:r>
                  <a:rPr lang="en-IN"/>
                  <a:t>% recovery</a:t>
                </a:r>
                <a:endParaRPr lang="en-IN" dirty="0"/>
              </a:p>
            </c:rich>
          </c:tx>
          <c:overlay val="0"/>
        </c:title>
        <c:numFmt formatCode="0" sourceLinked="1"/>
        <c:majorTickMark val="cross"/>
        <c:minorTickMark val="none"/>
        <c:tickLblPos val="nextTo"/>
        <c:spPr>
          <a:noFill/>
          <a:ln>
            <a:solidFill>
              <a:schemeClr val="dk1">
                <a:tint val="75000"/>
              </a:schemeClr>
            </a:solidFill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15295628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050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041C31-CD50-4DC4-8702-EC63DE7D2328}" type="datetimeFigureOut">
              <a:rPr lang="en-IN" smtClean="0"/>
              <a:t>05-12-202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5E3F92-F264-48C0-84BE-4231D3D6D66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9236775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041C31-CD50-4DC4-8702-EC63DE7D2328}" type="datetimeFigureOut">
              <a:rPr lang="en-IN" smtClean="0"/>
              <a:t>05-12-202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5E3F92-F264-48C0-84BE-4231D3D6D66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6216909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041C31-CD50-4DC4-8702-EC63DE7D2328}" type="datetimeFigureOut">
              <a:rPr lang="en-IN" smtClean="0"/>
              <a:t>05-12-202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5E3F92-F264-48C0-84BE-4231D3D6D66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0563313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041C31-CD50-4DC4-8702-EC63DE7D2328}" type="datetimeFigureOut">
              <a:rPr lang="en-IN" smtClean="0"/>
              <a:t>05-12-202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5E3F92-F264-48C0-84BE-4231D3D6D66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051872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041C31-CD50-4DC4-8702-EC63DE7D2328}" type="datetimeFigureOut">
              <a:rPr lang="en-IN" smtClean="0"/>
              <a:t>05-12-202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5E3F92-F264-48C0-84BE-4231D3D6D66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7773781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041C31-CD50-4DC4-8702-EC63DE7D2328}" type="datetimeFigureOut">
              <a:rPr lang="en-IN" smtClean="0"/>
              <a:t>05-12-2024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5E3F92-F264-48C0-84BE-4231D3D6D66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4095461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041C31-CD50-4DC4-8702-EC63DE7D2328}" type="datetimeFigureOut">
              <a:rPr lang="en-IN" smtClean="0"/>
              <a:t>05-12-2024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5E3F92-F264-48C0-84BE-4231D3D6D66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3912360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041C31-CD50-4DC4-8702-EC63DE7D2328}" type="datetimeFigureOut">
              <a:rPr lang="en-IN" smtClean="0"/>
              <a:t>05-12-2024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5E3F92-F264-48C0-84BE-4231D3D6D66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6266680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041C31-CD50-4DC4-8702-EC63DE7D2328}" type="datetimeFigureOut">
              <a:rPr lang="en-IN" smtClean="0"/>
              <a:t>05-12-2024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5E3F92-F264-48C0-84BE-4231D3D6D66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0683301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041C31-CD50-4DC4-8702-EC63DE7D2328}" type="datetimeFigureOut">
              <a:rPr lang="en-IN" smtClean="0"/>
              <a:t>05-12-2024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5E3F92-F264-48C0-84BE-4231D3D6D66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9700549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041C31-CD50-4DC4-8702-EC63DE7D2328}" type="datetimeFigureOut">
              <a:rPr lang="en-IN" smtClean="0"/>
              <a:t>05-12-2024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5E3F92-F264-48C0-84BE-4231D3D6D66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5991345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041C31-CD50-4DC4-8702-EC63DE7D2328}" type="datetimeFigureOut">
              <a:rPr lang="en-IN" smtClean="0"/>
              <a:t>05-12-202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5E3F92-F264-48C0-84BE-4231D3D6D66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8812240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2">
            <a:extLst>
              <a:ext uri="{FF2B5EF4-FFF2-40B4-BE49-F238E27FC236}">
                <a16:creationId xmlns:a16="http://schemas.microsoft.com/office/drawing/2014/main" id="{91B15F3B-3EA9-3520-6654-635ABC34694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51517" y="5877272"/>
            <a:ext cx="8285285" cy="64633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/>
            <a:r>
              <a:rPr lang="en-US" dirty="0">
                <a:latin typeface="Times New Roman" pitchFamily="18" charset="0"/>
                <a:ea typeface="DengXian" pitchFamily="2" charset="-122"/>
                <a:cs typeface="Times New Roman" pitchFamily="18" charset="0"/>
              </a:rPr>
              <a:t>Supplementary Figure 3a In vivo colonization of pomegranate by bacterial endophyte TC-310. </a:t>
            </a:r>
            <a:endParaRPr lang="en-IN" dirty="0">
              <a:latin typeface="Times New Roman" pitchFamily="18" charset="0"/>
              <a:ea typeface="DengXian" pitchFamily="2" charset="-122"/>
              <a:cs typeface="Times New Roman" pitchFamily="18" charset="0"/>
            </a:endParaRPr>
          </a:p>
        </p:txBody>
      </p:sp>
      <p:grpSp>
        <p:nvGrpSpPr>
          <p:cNvPr id="11" name="Group 10">
            <a:extLst>
              <a:ext uri="{FF2B5EF4-FFF2-40B4-BE49-F238E27FC236}">
                <a16:creationId xmlns:a16="http://schemas.microsoft.com/office/drawing/2014/main" id="{9679173D-0CAE-84B0-1F5A-B8D34A9CB92F}"/>
              </a:ext>
            </a:extLst>
          </p:cNvPr>
          <p:cNvGrpSpPr/>
          <p:nvPr/>
        </p:nvGrpSpPr>
        <p:grpSpPr>
          <a:xfrm>
            <a:off x="2319153" y="66368"/>
            <a:ext cx="4505693" cy="5680760"/>
            <a:chOff x="3347862" y="-19512"/>
            <a:chExt cx="4505693" cy="5680760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4692B62A-D1EA-1F0C-EB7B-DF0918E90EC2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821" t="34744" r="25180"/>
            <a:stretch/>
          </p:blipFill>
          <p:spPr>
            <a:xfrm rot="16200000">
              <a:off x="4145352" y="-817001"/>
              <a:ext cx="2880320" cy="4475297"/>
            </a:xfrm>
            <a:prstGeom prst="rect">
              <a:avLst/>
            </a:prstGeom>
          </p:spPr>
        </p:pic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D77FD84A-229C-D31A-59E7-96D4A64FDB32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5870" t="34744" r="30931"/>
            <a:stretch/>
          </p:blipFill>
          <p:spPr>
            <a:xfrm rot="16200000">
              <a:off x="4217360" y="1991311"/>
              <a:ext cx="2736304" cy="4475299"/>
            </a:xfrm>
            <a:prstGeom prst="rect">
              <a:avLst/>
            </a:prstGeom>
          </p:spPr>
        </p:pic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2AB00ACC-BA8A-4C17-F6EB-CB0AB62FCCDF}"/>
                </a:ext>
              </a:extLst>
            </p:cNvPr>
            <p:cNvSpPr txBox="1"/>
            <p:nvPr/>
          </p:nvSpPr>
          <p:spPr>
            <a:xfrm>
              <a:off x="3563885" y="2186280"/>
              <a:ext cx="1872211" cy="738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Endophytes recovered from TC-310 inoculated plants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EAEC3591-9697-95A7-907A-56EB6CCF179A}"/>
                </a:ext>
              </a:extLst>
            </p:cNvPr>
            <p:cNvSpPr txBox="1"/>
            <p:nvPr/>
          </p:nvSpPr>
          <p:spPr>
            <a:xfrm>
              <a:off x="5575749" y="2407230"/>
              <a:ext cx="210309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Water from last rinse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68FDE7E8-57AE-4368-ACB9-B12654CE104D}"/>
                </a:ext>
              </a:extLst>
            </p:cNvPr>
            <p:cNvSpPr txBox="1"/>
            <p:nvPr/>
          </p:nvSpPr>
          <p:spPr>
            <a:xfrm>
              <a:off x="5750463" y="5199876"/>
              <a:ext cx="210309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Water from last rinse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85C40532-7A40-799B-BDE0-FE6AE11A2117}"/>
                </a:ext>
              </a:extLst>
            </p:cNvPr>
            <p:cNvSpPr txBox="1"/>
            <p:nvPr/>
          </p:nvSpPr>
          <p:spPr>
            <a:xfrm>
              <a:off x="3439554" y="5138028"/>
              <a:ext cx="2212566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Endophytes isolated from un-inoculated plants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79488385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22" name="TextBox 2"/>
          <p:cNvSpPr txBox="1">
            <a:spLocks noChangeArrowheads="1"/>
          </p:cNvSpPr>
          <p:nvPr/>
        </p:nvSpPr>
        <p:spPr bwMode="auto">
          <a:xfrm>
            <a:off x="492370" y="4800600"/>
            <a:ext cx="8285285" cy="9233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/>
            <a:r>
              <a:rPr lang="en-US" dirty="0">
                <a:latin typeface="Times New Roman" pitchFamily="18" charset="0"/>
                <a:ea typeface="DengXian" pitchFamily="2" charset="-122"/>
                <a:cs typeface="Times New Roman" pitchFamily="18" charset="0"/>
              </a:rPr>
              <a:t>Supplementary Figure 3b Recovery of endophyte from pomegranate leaves exogenously inoculated with TC-310 (B. tequilensis) up to 7 days. Values presented are mean of three replicates and error bars are based on standard deviation. </a:t>
            </a:r>
            <a:endParaRPr lang="en-IN" dirty="0">
              <a:latin typeface="Times New Roman" pitchFamily="18" charset="0"/>
              <a:ea typeface="DengXian" pitchFamily="2" charset="-122"/>
              <a:cs typeface="Times New Roman" pitchFamily="18" charset="0"/>
            </a:endParaRPr>
          </a:p>
        </p:txBody>
      </p:sp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2818931"/>
              </p:ext>
            </p:extLst>
          </p:nvPr>
        </p:nvGraphicFramePr>
        <p:xfrm>
          <a:off x="2267744" y="2057400"/>
          <a:ext cx="441441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79541387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</TotalTime>
  <Words>78</Words>
  <Application>Microsoft Office PowerPoint</Application>
  <PresentationFormat>On-screen Show (4:3)</PresentationFormat>
  <Paragraphs>9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Times New Roman</vt:lpstr>
      <vt:lpstr>Office Theme</vt:lpstr>
      <vt:lpstr>PowerPoint Presentation</vt:lpstr>
      <vt:lpstr>PowerPoint Presentation</vt:lpstr>
    </vt:vector>
  </TitlesOfParts>
  <Company>HP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omnath</dc:creator>
  <cp:lastModifiedBy>Abby Rassette</cp:lastModifiedBy>
  <cp:revision>11</cp:revision>
  <dcterms:created xsi:type="dcterms:W3CDTF">2024-09-04T07:36:04Z</dcterms:created>
  <dcterms:modified xsi:type="dcterms:W3CDTF">2024-12-05T10:23:20Z</dcterms:modified>
</cp:coreProperties>
</file>